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4D984-48F0-4626-AFCB-E0632BDD57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998B0-1718-412A-91A2-2E1724072D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F69E4-0671-4458-B830-7775DBB55A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92C36-2CAB-4810-94AA-C01A6B6752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18273-AEF5-40D8-8C05-7EDEF50C74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7974C-A8D1-49BC-AEE9-BD0F791959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4C834-7EED-41C0-B060-479E62F211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EB21A-B873-4982-8486-7D870A3AEC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68D9C-9018-4229-87F1-D020C3D28E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F8BEC-798C-403D-A891-1761845EE2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F8618-F788-4FDF-87E1-6C7553DDB0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FF02D-D7E0-4EBF-9B20-791AB1DFD4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A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A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16A081-603F-4FC1-A1A1-000EB87C2AB0}" type="slidenum">
              <a:rPr b="0" lang="es-A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56 Grupo"/>
          <p:cNvGrpSpPr/>
          <p:nvPr/>
        </p:nvGrpSpPr>
        <p:grpSpPr>
          <a:xfrm>
            <a:off x="446760" y="287280"/>
            <a:ext cx="8340120" cy="6213600"/>
            <a:chOff x="446760" y="287280"/>
            <a:chExt cx="8340120" cy="6213600"/>
          </a:xfrm>
        </p:grpSpPr>
        <p:pic>
          <p:nvPicPr>
            <p:cNvPr id="42" name="Picture 57" descr=""/>
            <p:cNvPicPr/>
            <p:nvPr/>
          </p:nvPicPr>
          <p:blipFill>
            <a:blip r:embed="rId1"/>
            <a:stretch/>
          </p:blipFill>
          <p:spPr>
            <a:xfrm>
              <a:off x="5195880" y="479160"/>
              <a:ext cx="3591000" cy="3544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33 Grupo"/>
            <p:cNvGrpSpPr/>
            <p:nvPr/>
          </p:nvGrpSpPr>
          <p:grpSpPr>
            <a:xfrm>
              <a:off x="446760" y="4408560"/>
              <a:ext cx="3261960" cy="2092320"/>
              <a:chOff x="446760" y="4408560"/>
              <a:chExt cx="3261960" cy="2092320"/>
            </a:xfrm>
          </p:grpSpPr>
          <p:sp>
            <p:nvSpPr>
              <p:cNvPr id="44" name="10 CuadroTexto"/>
              <p:cNvSpPr/>
              <p:nvPr/>
            </p:nvSpPr>
            <p:spPr>
              <a:xfrm>
                <a:off x="446760" y="4408560"/>
                <a:ext cx="60444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2400" spc="-1" strike="noStrike">
                    <a:solidFill>
                      <a:srgbClr val="000000"/>
                    </a:solidFill>
                    <a:latin typeface="Arial"/>
                  </a:rPr>
                  <a:t>(B)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52 Grupo"/>
              <p:cNvGrpSpPr/>
              <p:nvPr/>
            </p:nvGrpSpPr>
            <p:grpSpPr>
              <a:xfrm>
                <a:off x="806400" y="4765680"/>
                <a:ext cx="2902320" cy="1735200"/>
                <a:chOff x="806400" y="4765680"/>
                <a:chExt cx="2902320" cy="1735200"/>
              </a:xfrm>
            </p:grpSpPr>
            <p:pic>
              <p:nvPicPr>
                <p:cNvPr id="46" name="Picture 33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871200" y="5212440"/>
                  <a:ext cx="2666520" cy="12884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7" name="35 Rectángulo"/>
                <p:cNvSpPr/>
                <p:nvPr/>
              </p:nvSpPr>
              <p:spPr>
                <a:xfrm>
                  <a:off x="1279440" y="4777560"/>
                  <a:ext cx="5158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PVX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18 Conector recto"/>
                <p:cNvSpPr/>
                <p:nvPr/>
              </p:nvSpPr>
              <p:spPr>
                <a:xfrm>
                  <a:off x="942480" y="4992480"/>
                  <a:ext cx="12146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40 CuadroTexto"/>
                <p:cNvSpPr/>
                <p:nvPr/>
              </p:nvSpPr>
              <p:spPr>
                <a:xfrm>
                  <a:off x="806400" y="4979880"/>
                  <a:ext cx="1558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300     200   100   50 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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g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42 CuadroTexto"/>
                <p:cNvSpPr/>
                <p:nvPr/>
              </p:nvSpPr>
              <p:spPr>
                <a:xfrm>
                  <a:off x="2356200" y="4992120"/>
                  <a:ext cx="13525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    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10      20      30 ng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43 CuadroTexto"/>
                <p:cNvSpPr/>
                <p:nvPr/>
              </p:nvSpPr>
              <p:spPr>
                <a:xfrm>
                  <a:off x="2520000" y="4765680"/>
                  <a:ext cx="988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E. Coli  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SAG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22 Conector recto"/>
                <p:cNvSpPr/>
                <p:nvPr/>
              </p:nvSpPr>
              <p:spPr>
                <a:xfrm>
                  <a:off x="2500200" y="4989240"/>
                  <a:ext cx="100008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3" name="21 CuadroTexto"/>
              <p:cNvSpPr/>
              <p:nvPr/>
            </p:nvSpPr>
            <p:spPr>
              <a:xfrm>
                <a:off x="2183400" y="4765680"/>
                <a:ext cx="328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AR" sz="14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32 Grupo"/>
            <p:cNvGrpSpPr/>
            <p:nvPr/>
          </p:nvGrpSpPr>
          <p:grpSpPr>
            <a:xfrm>
              <a:off x="503640" y="287280"/>
              <a:ext cx="3601080" cy="3621240"/>
              <a:chOff x="503640" y="287280"/>
              <a:chExt cx="3601080" cy="3621240"/>
            </a:xfrm>
          </p:grpSpPr>
          <p:sp>
            <p:nvSpPr>
              <p:cNvPr id="55" name="53 CuadroTexto"/>
              <p:cNvSpPr/>
              <p:nvPr/>
            </p:nvSpPr>
            <p:spPr>
              <a:xfrm>
                <a:off x="503640" y="287280"/>
                <a:ext cx="60444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2400" spc="-1" strike="noStrike">
                    <a:solidFill>
                      <a:srgbClr val="000000"/>
                    </a:solidFill>
                    <a:latin typeface="Arial"/>
                  </a:rPr>
                  <a:t>(A)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6" name="37 Grupo"/>
              <p:cNvGrpSpPr/>
              <p:nvPr/>
            </p:nvGrpSpPr>
            <p:grpSpPr>
              <a:xfrm>
                <a:off x="664560" y="2249640"/>
                <a:ext cx="3335760" cy="1658880"/>
                <a:chOff x="664560" y="2249640"/>
                <a:chExt cx="3335760" cy="1658880"/>
              </a:xfrm>
            </p:grpSpPr>
            <p:sp>
              <p:nvSpPr>
                <p:cNvPr id="57" name="5 CuadroTexto"/>
                <p:cNvSpPr/>
                <p:nvPr/>
              </p:nvSpPr>
              <p:spPr>
                <a:xfrm>
                  <a:off x="664560" y="2249640"/>
                  <a:ext cx="3335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        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GV      M    PVXS   AS    AnS   AoS   KnS    Ko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58" name="Picture 28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939600" y="2479680"/>
                  <a:ext cx="2897280" cy="14288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9" name="29 Grupo"/>
              <p:cNvGrpSpPr/>
              <p:nvPr/>
            </p:nvGrpSpPr>
            <p:grpSpPr>
              <a:xfrm>
                <a:off x="785160" y="625320"/>
                <a:ext cx="3215160" cy="1623960"/>
                <a:chOff x="785160" y="625320"/>
                <a:chExt cx="3215160" cy="1623960"/>
              </a:xfrm>
            </p:grpSpPr>
            <p:sp>
              <p:nvSpPr>
                <p:cNvPr id="60" name="5 CuadroTexto"/>
                <p:cNvSpPr/>
                <p:nvPr/>
              </p:nvSpPr>
              <p:spPr>
                <a:xfrm>
                  <a:off x="785160" y="625320"/>
                  <a:ext cx="3215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      </a:t>
                  </a:r>
                  <a:r>
                    <a:rPr b="1" lang="es-AR" sz="1000" spc="-1" strike="noStrike">
                      <a:solidFill>
                        <a:srgbClr val="000000"/>
                      </a:solidFill>
                      <a:latin typeface="Arial"/>
                    </a:rPr>
                    <a:t>GV     M   PVXS   AS    AnS   AoS   KnS    Ko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61" name="Picture 29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999360" y="891720"/>
                  <a:ext cx="2862720" cy="13575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cxnSp>
            <p:nvCxnSpPr>
              <p:cNvPr id="62" name="30 Conector recto de flecha"/>
              <p:cNvCxnSpPr/>
              <p:nvPr/>
            </p:nvCxnSpPr>
            <p:spPr>
              <a:xfrm flipH="1" flipV="1">
                <a:off x="3856680" y="1495080"/>
                <a:ext cx="214920" cy="2160"/>
              </a:xfrm>
              <a:prstGeom prst="straightConnector1">
                <a:avLst/>
              </a:prstGeom>
              <a:ln w="2844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63" name="31 Conector recto de flecha"/>
              <p:cNvCxnSpPr/>
              <p:nvPr/>
            </p:nvCxnSpPr>
            <p:spPr>
              <a:xfrm flipH="1" flipV="1">
                <a:off x="3890160" y="2144520"/>
                <a:ext cx="214920" cy="2160"/>
              </a:xfrm>
              <a:prstGeom prst="straightConnector1">
                <a:avLst/>
              </a:prstGeom>
              <a:ln w="2844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sp>
          <p:nvSpPr>
            <p:cNvPr id="64" name="53 CuadroTexto"/>
            <p:cNvSpPr/>
            <p:nvPr/>
          </p:nvSpPr>
          <p:spPr>
            <a:xfrm>
              <a:off x="5076000" y="303120"/>
              <a:ext cx="6044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AR" sz="2400" spc="-1" strike="noStrike">
                  <a:solidFill>
                    <a:srgbClr val="000000"/>
                  </a:solidFill>
                  <a:latin typeface="Arial"/>
                </a:rPr>
                <a:t>(C)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" name="45 Grupo"/>
            <p:cNvGrpSpPr/>
            <p:nvPr/>
          </p:nvGrpSpPr>
          <p:grpSpPr>
            <a:xfrm>
              <a:off x="690120" y="765000"/>
              <a:ext cx="398160" cy="1120320"/>
              <a:chOff x="690120" y="765000"/>
              <a:chExt cx="398160" cy="1120320"/>
            </a:xfrm>
          </p:grpSpPr>
          <p:sp>
            <p:nvSpPr>
              <p:cNvPr id="66" name="40 CuadroTexto"/>
              <p:cNvSpPr/>
              <p:nvPr/>
            </p:nvSpPr>
            <p:spPr>
              <a:xfrm>
                <a:off x="715680" y="765000"/>
                <a:ext cx="36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41 CuadroTexto"/>
              <p:cNvSpPr/>
              <p:nvPr/>
            </p:nvSpPr>
            <p:spPr>
              <a:xfrm>
                <a:off x="720360" y="920520"/>
                <a:ext cx="36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42 CuadroTexto"/>
              <p:cNvSpPr/>
              <p:nvPr/>
            </p:nvSpPr>
            <p:spPr>
              <a:xfrm>
                <a:off x="712080" y="1128960"/>
                <a:ext cx="36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43 CuadroTexto"/>
              <p:cNvSpPr/>
              <p:nvPr/>
            </p:nvSpPr>
            <p:spPr>
              <a:xfrm>
                <a:off x="702720" y="1348920"/>
                <a:ext cx="36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44 CuadroTexto"/>
              <p:cNvSpPr/>
              <p:nvPr/>
            </p:nvSpPr>
            <p:spPr>
              <a:xfrm>
                <a:off x="690120" y="1608840"/>
                <a:ext cx="367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2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46 Grupo"/>
            <p:cNvGrpSpPr/>
            <p:nvPr/>
          </p:nvGrpSpPr>
          <p:grpSpPr>
            <a:xfrm>
              <a:off x="499680" y="5073840"/>
              <a:ext cx="396720" cy="1069560"/>
              <a:chOff x="499680" y="5073840"/>
              <a:chExt cx="396720" cy="1069560"/>
            </a:xfrm>
          </p:grpSpPr>
          <p:sp>
            <p:nvSpPr>
              <p:cNvPr id="72" name="47 CuadroTexto"/>
              <p:cNvSpPr/>
              <p:nvPr/>
            </p:nvSpPr>
            <p:spPr>
              <a:xfrm>
                <a:off x="525240" y="507384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48 CuadroTexto"/>
              <p:cNvSpPr/>
              <p:nvPr/>
            </p:nvSpPr>
            <p:spPr>
              <a:xfrm>
                <a:off x="529560" y="522936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49 CuadroTexto"/>
              <p:cNvSpPr/>
              <p:nvPr/>
            </p:nvSpPr>
            <p:spPr>
              <a:xfrm>
                <a:off x="521280" y="539928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50 CuadroTexto"/>
              <p:cNvSpPr/>
              <p:nvPr/>
            </p:nvSpPr>
            <p:spPr>
              <a:xfrm>
                <a:off x="512280" y="563256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51 CuadroTexto"/>
              <p:cNvSpPr/>
              <p:nvPr/>
            </p:nvSpPr>
            <p:spPr>
              <a:xfrm>
                <a:off x="499680" y="586692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2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" name="52 Grupo"/>
            <p:cNvGrpSpPr/>
            <p:nvPr/>
          </p:nvGrpSpPr>
          <p:grpSpPr>
            <a:xfrm>
              <a:off x="642600" y="2446200"/>
              <a:ext cx="396720" cy="1108800"/>
              <a:chOff x="642600" y="2446200"/>
              <a:chExt cx="396720" cy="1108800"/>
            </a:xfrm>
          </p:grpSpPr>
          <p:sp>
            <p:nvSpPr>
              <p:cNvPr id="78" name="53 CuadroTexto"/>
              <p:cNvSpPr/>
              <p:nvPr/>
            </p:nvSpPr>
            <p:spPr>
              <a:xfrm>
                <a:off x="668160" y="244620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54 CuadroTexto"/>
              <p:cNvSpPr/>
              <p:nvPr/>
            </p:nvSpPr>
            <p:spPr>
              <a:xfrm>
                <a:off x="672480" y="263052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55 CuadroTexto"/>
              <p:cNvSpPr/>
              <p:nvPr/>
            </p:nvSpPr>
            <p:spPr>
              <a:xfrm>
                <a:off x="664200" y="277200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4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56 CuadroTexto"/>
              <p:cNvSpPr/>
              <p:nvPr/>
            </p:nvSpPr>
            <p:spPr>
              <a:xfrm>
                <a:off x="655200" y="301824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57 CuadroTexto"/>
              <p:cNvSpPr/>
              <p:nvPr/>
            </p:nvSpPr>
            <p:spPr>
              <a:xfrm>
                <a:off x="642600" y="3278520"/>
                <a:ext cx="36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s-AR" sz="1200" spc="-1" strike="noStrike">
                    <a:solidFill>
                      <a:srgbClr val="000000"/>
                    </a:solidFill>
                    <a:latin typeface="Arial"/>
                  </a:rPr>
                  <a:t>2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83" name="58 Conector recto de flecha"/>
            <p:cNvCxnSpPr/>
            <p:nvPr/>
          </p:nvCxnSpPr>
          <p:spPr>
            <a:xfrm flipH="1" flipV="1">
              <a:off x="2226240" y="5719680"/>
              <a:ext cx="214920" cy="21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84" name="59 Conector recto de flecha"/>
            <p:cNvCxnSpPr/>
            <p:nvPr/>
          </p:nvCxnSpPr>
          <p:spPr>
            <a:xfrm flipH="1" flipV="1">
              <a:off x="2213640" y="6337080"/>
              <a:ext cx="214920" cy="216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arrow" w="med"/>
            </a:ln>
          </p:spPr>
        </p:cxnSp>
        <p:grpSp>
          <p:nvGrpSpPr>
            <p:cNvPr id="85" name="57 Grupo"/>
            <p:cNvGrpSpPr/>
            <p:nvPr/>
          </p:nvGrpSpPr>
          <p:grpSpPr>
            <a:xfrm>
              <a:off x="5147640" y="4470480"/>
              <a:ext cx="3496680" cy="1235160"/>
              <a:chOff x="5147640" y="4470480"/>
              <a:chExt cx="3496680" cy="1235160"/>
            </a:xfrm>
          </p:grpSpPr>
          <p:grpSp>
            <p:nvGrpSpPr>
              <p:cNvPr id="86" name="34 Grupo"/>
              <p:cNvGrpSpPr/>
              <p:nvPr/>
            </p:nvGrpSpPr>
            <p:grpSpPr>
              <a:xfrm>
                <a:off x="5147640" y="4470480"/>
                <a:ext cx="3362040" cy="1188000"/>
                <a:chOff x="5147640" y="4470480"/>
                <a:chExt cx="3362040" cy="1188000"/>
              </a:xfrm>
            </p:grpSpPr>
            <p:sp>
              <p:nvSpPr>
                <p:cNvPr id="87" name="11 CuadroTexto"/>
                <p:cNvSpPr/>
                <p:nvPr/>
              </p:nvSpPr>
              <p:spPr>
                <a:xfrm>
                  <a:off x="5147640" y="4470480"/>
                  <a:ext cx="604440" cy="459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s-AR" sz="2400" spc="-1" strike="noStrike">
                      <a:solidFill>
                        <a:srgbClr val="000000"/>
                      </a:solidFill>
                      <a:latin typeface="Arial"/>
                    </a:rPr>
                    <a:t>(D)</a:t>
                  </a: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8" name="28 Grupo"/>
                <p:cNvGrpSpPr/>
                <p:nvPr/>
              </p:nvGrpSpPr>
              <p:grpSpPr>
                <a:xfrm>
                  <a:off x="5177520" y="4959360"/>
                  <a:ext cx="3332160" cy="699120"/>
                  <a:chOff x="5177520" y="4959360"/>
                  <a:chExt cx="3332160" cy="699120"/>
                </a:xfrm>
              </p:grpSpPr>
              <p:sp>
                <p:nvSpPr>
                  <p:cNvPr id="89" name="Rectangle 8"/>
                  <p:cNvSpPr/>
                  <p:nvPr/>
                </p:nvSpPr>
                <p:spPr>
                  <a:xfrm>
                    <a:off x="5730840" y="4970160"/>
                    <a:ext cx="15004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GV        PVXS    AS          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Rectangle 9"/>
                  <p:cNvSpPr/>
                  <p:nvPr/>
                </p:nvSpPr>
                <p:spPr>
                  <a:xfrm>
                    <a:off x="6974280" y="4959360"/>
                    <a:ext cx="34776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  </a:t>
                    </a: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AnS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Rectangle 10"/>
                  <p:cNvSpPr/>
                  <p:nvPr/>
                </p:nvSpPr>
                <p:spPr>
                  <a:xfrm>
                    <a:off x="7354080" y="4972680"/>
                    <a:ext cx="3240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  </a:t>
                    </a: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AoS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Rectangle 11"/>
                  <p:cNvSpPr/>
                  <p:nvPr/>
                </p:nvSpPr>
                <p:spPr>
                  <a:xfrm>
                    <a:off x="7779600" y="4972680"/>
                    <a:ext cx="43596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  </a:t>
                    </a: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KnS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Rectangle 12"/>
                  <p:cNvSpPr/>
                  <p:nvPr/>
                </p:nvSpPr>
                <p:spPr>
                  <a:xfrm>
                    <a:off x="8255880" y="4970160"/>
                    <a:ext cx="253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000" spc="-1" strike="noStrike">
                        <a:solidFill>
                          <a:srgbClr val="000000"/>
                        </a:solidFill>
                        <a:latin typeface="Arial"/>
                      </a:rPr>
                      <a:t>KoS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Rectangle 13"/>
                  <p:cNvSpPr/>
                  <p:nvPr/>
                </p:nvSpPr>
                <p:spPr>
                  <a:xfrm>
                    <a:off x="5208840" y="5475600"/>
                    <a:ext cx="3816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200" spc="-1" strike="noStrike">
                        <a:solidFill>
                          <a:srgbClr val="000000"/>
                        </a:solidFill>
                        <a:latin typeface="Arial"/>
                      </a:rPr>
                      <a:t>Actin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Rectangle 14"/>
                  <p:cNvSpPr/>
                  <p:nvPr/>
                </p:nvSpPr>
                <p:spPr>
                  <a:xfrm>
                    <a:off x="5177520" y="5171040"/>
                    <a:ext cx="41688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s-AR" sz="1200" spc="-1" strike="noStrike">
                        <a:solidFill>
                          <a:srgbClr val="000000"/>
                        </a:solidFill>
                        <a:latin typeface="Arial"/>
                      </a:rPr>
                      <a:t>SAG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pic>
            <p:nvPicPr>
              <p:cNvPr id="96" name="Picture 2" descr=""/>
              <p:cNvPicPr/>
              <p:nvPr/>
            </p:nvPicPr>
            <p:blipFill>
              <a:blip r:embed="rId5"/>
              <a:stretch/>
            </p:blipFill>
            <p:spPr>
              <a:xfrm>
                <a:off x="5643720" y="5122080"/>
                <a:ext cx="3000600" cy="58356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4T13:20:53Z</dcterms:created>
  <dc:creator>marina</dc:creator>
  <dc:description/>
  <dc:language>en-US</dc:language>
  <cp:lastModifiedBy>Usuario</cp:lastModifiedBy>
  <dcterms:modified xsi:type="dcterms:W3CDTF">2010-04-29T17:57:00Z</dcterms:modified>
  <cp:revision>19</cp:revision>
  <dc:subject/>
  <dc:title>Diapositiva 1</dc:title>
</cp:coreProperties>
</file>